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400800" cy="8229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92">
          <p15:clr>
            <a:srgbClr val="A4A3A4"/>
          </p15:clr>
        </p15:guide>
        <p15:guide id="2" pos="201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9"/>
    <p:restoredTop sz="94663"/>
  </p:normalViewPr>
  <p:slideViewPr>
    <p:cSldViewPr snapToGrid="0" snapToObjects="1">
      <p:cViewPr varScale="1">
        <p:scale>
          <a:sx n="97" d="100"/>
          <a:sy n="97" d="100"/>
        </p:scale>
        <p:origin x="2784" y="216"/>
      </p:cViewPr>
      <p:guideLst>
        <p:guide orient="horz" pos="2592"/>
        <p:guide pos="201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" y="2556511"/>
            <a:ext cx="5440680" cy="176403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60120" y="4663440"/>
            <a:ext cx="4480560" cy="210312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BC1A0-BDF5-6B4A-930C-A6327C128C91}" type="datetimeFigureOut">
              <a:rPr lang="en-US" smtClean="0"/>
              <a:t>6/2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85833-757A-EB4F-A457-A4323D978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05874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BC1A0-BDF5-6B4A-930C-A6327C128C91}" type="datetimeFigureOut">
              <a:rPr lang="en-US" smtClean="0"/>
              <a:t>6/2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85833-757A-EB4F-A457-A4323D978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95230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248184" y="396240"/>
            <a:ext cx="1007903" cy="842581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24472" y="396240"/>
            <a:ext cx="2917032" cy="842581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BC1A0-BDF5-6B4A-930C-A6327C128C91}" type="datetimeFigureOut">
              <a:rPr lang="en-US" smtClean="0"/>
              <a:t>6/2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85833-757A-EB4F-A457-A4323D978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26501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BC1A0-BDF5-6B4A-930C-A6327C128C91}" type="datetimeFigureOut">
              <a:rPr lang="en-US" smtClean="0"/>
              <a:t>6/2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85833-757A-EB4F-A457-A4323D978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91191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5619" y="5288281"/>
            <a:ext cx="5440680" cy="163449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5619" y="3488056"/>
            <a:ext cx="5440680" cy="180022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BC1A0-BDF5-6B4A-930C-A6327C128C91}" type="datetimeFigureOut">
              <a:rPr lang="en-US" smtClean="0"/>
              <a:t>6/2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85833-757A-EB4F-A457-A4323D978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6962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24473" y="2305050"/>
            <a:ext cx="1962468" cy="651700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293620" y="2305050"/>
            <a:ext cx="1962468" cy="651700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BC1A0-BDF5-6B4A-930C-A6327C128C91}" type="datetimeFigureOut">
              <a:rPr lang="en-US" smtClean="0"/>
              <a:t>6/2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85833-757A-EB4F-A457-A4323D978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94943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0040" y="329566"/>
            <a:ext cx="5760720" cy="13716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0" y="1842136"/>
            <a:ext cx="2828132" cy="76771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0040" y="2609850"/>
            <a:ext cx="2828132" cy="474154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51518" y="1842136"/>
            <a:ext cx="2829243" cy="76771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51518" y="2609850"/>
            <a:ext cx="2829243" cy="474154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BC1A0-BDF5-6B4A-930C-A6327C128C91}" type="datetimeFigureOut">
              <a:rPr lang="en-US" smtClean="0"/>
              <a:t>6/24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85833-757A-EB4F-A457-A4323D978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82226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BC1A0-BDF5-6B4A-930C-A6327C128C91}" type="datetimeFigureOut">
              <a:rPr lang="en-US" smtClean="0"/>
              <a:t>6/24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85833-757A-EB4F-A457-A4323D978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44564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BC1A0-BDF5-6B4A-930C-A6327C128C91}" type="datetimeFigureOut">
              <a:rPr lang="en-US" smtClean="0"/>
              <a:t>6/24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85833-757A-EB4F-A457-A4323D978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2288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0040" y="327660"/>
            <a:ext cx="2105819" cy="139446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02535" y="327660"/>
            <a:ext cx="3578225" cy="702373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0040" y="1722120"/>
            <a:ext cx="2105819" cy="562927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BC1A0-BDF5-6B4A-930C-A6327C128C91}" type="datetimeFigureOut">
              <a:rPr lang="en-US" smtClean="0"/>
              <a:t>6/2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85833-757A-EB4F-A457-A4323D978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72462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4602" y="5760720"/>
            <a:ext cx="3840480" cy="68008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54602" y="735330"/>
            <a:ext cx="3840480" cy="493776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4602" y="6440806"/>
            <a:ext cx="3840480" cy="96583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BC1A0-BDF5-6B4A-930C-A6327C128C91}" type="datetimeFigureOut">
              <a:rPr lang="en-US" smtClean="0"/>
              <a:t>6/2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85833-757A-EB4F-A457-A4323D978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84258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0040" y="329566"/>
            <a:ext cx="5760720" cy="1371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0" y="1920240"/>
            <a:ext cx="5760720" cy="54311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0040" y="7627621"/>
            <a:ext cx="149352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0BC1A0-BDF5-6B4A-930C-A6327C128C91}" type="datetimeFigureOut">
              <a:rPr lang="en-US" smtClean="0"/>
              <a:t>6/2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86940" y="7627621"/>
            <a:ext cx="202692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87240" y="7627621"/>
            <a:ext cx="149352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385833-757A-EB4F-A457-A4323D978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3409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5963" y="13003"/>
            <a:ext cx="2926080" cy="2958957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06333" y="2760959"/>
            <a:ext cx="2926080" cy="2769725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900" y="2667000"/>
            <a:ext cx="2926080" cy="2823610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2114" y="89059"/>
            <a:ext cx="2743200" cy="259661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9767147" y="1280160"/>
            <a:ext cx="161159" cy="326801"/>
          </a:xfrm>
          <a:prstGeom prst="rect">
            <a:avLst/>
          </a:prstGeom>
          <a:noFill/>
        </p:spPr>
        <p:txBody>
          <a:bodyPr wrap="none" lIns="79800" tIns="39900" rIns="79800" bIns="39900" rtlCol="0">
            <a:spAutoFit/>
          </a:bodyPr>
          <a:lstStyle/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127015" y="76858"/>
            <a:ext cx="381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225696" y="2669484"/>
            <a:ext cx="381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Times New Roman"/>
                <a:cs typeface="Times New Roman"/>
              </a:rPr>
              <a:t>D</a:t>
            </a:r>
            <a:endParaRPr lang="en-US" sz="1100" dirty="0">
              <a:latin typeface="Times New Roman"/>
              <a:cs typeface="Times New Roman"/>
            </a:endParaRPr>
          </a:p>
        </p:txBody>
      </p:sp>
      <p:sp>
        <p:nvSpPr>
          <p:cNvPr id="8" name="TextBox 7"/>
          <p:cNvSpPr txBox="1"/>
          <p:nvPr/>
        </p:nvSpPr>
        <p:spPr>
          <a:xfrm flipH="1">
            <a:off x="97311" y="2583350"/>
            <a:ext cx="2792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C</a:t>
            </a:r>
          </a:p>
        </p:txBody>
      </p:sp>
      <p:cxnSp>
        <p:nvCxnSpPr>
          <p:cNvPr id="9" name="Straight Connector 8"/>
          <p:cNvCxnSpPr/>
          <p:nvPr/>
        </p:nvCxnSpPr>
        <p:spPr>
          <a:xfrm>
            <a:off x="1206565" y="615187"/>
            <a:ext cx="1299629" cy="1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1651066" y="408416"/>
            <a:ext cx="3894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  <a:cs typeface="Times New Roman"/>
              </a:rPr>
              <a:t>*</a:t>
            </a:r>
          </a:p>
        </p:txBody>
      </p:sp>
      <p:cxnSp>
        <p:nvCxnSpPr>
          <p:cNvPr id="11" name="Straight Connector 10"/>
          <p:cNvCxnSpPr/>
          <p:nvPr/>
        </p:nvCxnSpPr>
        <p:spPr>
          <a:xfrm>
            <a:off x="880646" y="3110145"/>
            <a:ext cx="1612903" cy="1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1498721" y="2928774"/>
            <a:ext cx="3894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  <a:cs typeface="Times New Roman"/>
              </a:rPr>
              <a:t>*</a:t>
            </a:r>
          </a:p>
        </p:txBody>
      </p:sp>
      <p:cxnSp>
        <p:nvCxnSpPr>
          <p:cNvPr id="19" name="Straight Connector 18"/>
          <p:cNvCxnSpPr/>
          <p:nvPr/>
        </p:nvCxnSpPr>
        <p:spPr>
          <a:xfrm flipV="1">
            <a:off x="3924306" y="3082696"/>
            <a:ext cx="1881637" cy="3567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3924306" y="3213260"/>
            <a:ext cx="1297439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4296834" y="3019196"/>
            <a:ext cx="3894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  <a:cs typeface="Times New Roman"/>
              </a:rPr>
              <a:t>**</a:t>
            </a:r>
          </a:p>
        </p:txBody>
      </p:sp>
      <p:cxnSp>
        <p:nvCxnSpPr>
          <p:cNvPr id="22" name="Straight Connector 21"/>
          <p:cNvCxnSpPr/>
          <p:nvPr/>
        </p:nvCxnSpPr>
        <p:spPr>
          <a:xfrm>
            <a:off x="3924300" y="3323323"/>
            <a:ext cx="670918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4042823" y="3154660"/>
            <a:ext cx="4444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  <a:cs typeface="Times New Roman"/>
              </a:rPr>
              <a:t>**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4487323" y="2900659"/>
            <a:ext cx="7344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  <a:cs typeface="Times New Roman"/>
              </a:rPr>
              <a:t>**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225696" y="120515"/>
            <a:ext cx="381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B</a:t>
            </a:r>
          </a:p>
        </p:txBody>
      </p:sp>
      <p:cxnSp>
        <p:nvCxnSpPr>
          <p:cNvPr id="26" name="Straight Connector 25"/>
          <p:cNvCxnSpPr/>
          <p:nvPr/>
        </p:nvCxnSpPr>
        <p:spPr>
          <a:xfrm>
            <a:off x="4212173" y="521591"/>
            <a:ext cx="1159927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4656674" y="314820"/>
            <a:ext cx="3894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  <a:cs typeface="Times New Roman"/>
              </a:rPr>
              <a:t>*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76200" y="5608186"/>
            <a:ext cx="61722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/>
                <a:cs typeface="Times New Roman"/>
              </a:rPr>
              <a:t>Supplementary </a:t>
            </a:r>
            <a:r>
              <a:rPr lang="en-US" sz="1200" b="1">
                <a:latin typeface="Times New Roman"/>
                <a:cs typeface="Times New Roman"/>
              </a:rPr>
              <a:t>Figure </a:t>
            </a:r>
            <a:r>
              <a:rPr lang="en-US" altLang="zh-CN" sz="1200" b="1">
                <a:latin typeface="Times New Roman"/>
                <a:cs typeface="Times New Roman"/>
              </a:rPr>
              <a:t>8</a:t>
            </a:r>
            <a:r>
              <a:rPr lang="en-US" sz="1200" b="1">
                <a:latin typeface="Times New Roman"/>
                <a:cs typeface="Times New Roman"/>
              </a:rPr>
              <a:t>.</a:t>
            </a:r>
            <a:r>
              <a:rPr lang="en-US" sz="1200">
                <a:latin typeface="Times New Roman"/>
                <a:cs typeface="Times New Roman"/>
              </a:rPr>
              <a:t> </a:t>
            </a:r>
            <a:r>
              <a:rPr lang="en-US" altLang="zh-CN" sz="1200" dirty="0">
                <a:latin typeface="Times New Roman"/>
                <a:cs typeface="Times New Roman"/>
              </a:rPr>
              <a:t>Relative frequencies of </a:t>
            </a:r>
            <a:r>
              <a:rPr lang="en-US" altLang="zh-CN" sz="1200" dirty="0" err="1">
                <a:latin typeface="Times New Roman"/>
                <a:cs typeface="Times New Roman"/>
              </a:rPr>
              <a:t>Enterobacteriaceae</a:t>
            </a:r>
            <a:r>
              <a:rPr lang="en-US" altLang="zh-CN" sz="1200" dirty="0">
                <a:latin typeface="Times New Roman"/>
                <a:cs typeface="Times New Roman"/>
              </a:rPr>
              <a:t>(A), Staphylococcus(B), Enterococcus(C), and Lactobacillus(D) are depicted here. </a:t>
            </a:r>
            <a:r>
              <a:rPr lang="en-US" sz="1200" dirty="0">
                <a:latin typeface="Times New Roman"/>
                <a:cs typeface="Times New Roman"/>
              </a:rPr>
              <a:t>ANOVA followed by Bonferroni correction</a:t>
            </a:r>
            <a:r>
              <a:rPr lang="en-US" sz="1200" dirty="0"/>
              <a:t> </a:t>
            </a:r>
            <a:r>
              <a:rPr lang="en-US" altLang="zh-CN" sz="1200" dirty="0">
                <a:latin typeface="Times New Roman"/>
                <a:cs typeface="Times New Roman"/>
              </a:rPr>
              <a:t>*p&lt;0.05,**p&lt;0.01</a:t>
            </a:r>
            <a:endParaRPr 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0526582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51</Words>
  <Application>Microsoft Macintosh PowerPoint</Application>
  <PresentationFormat>Custom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1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ngjing Meng</dc:creator>
  <cp:lastModifiedBy>Meng, Jingjing</cp:lastModifiedBy>
  <cp:revision>10</cp:revision>
  <dcterms:created xsi:type="dcterms:W3CDTF">2018-12-13T17:45:35Z</dcterms:created>
  <dcterms:modified xsi:type="dcterms:W3CDTF">2019-06-24T14:25:59Z</dcterms:modified>
</cp:coreProperties>
</file>